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1493" y="-8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8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8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8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8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8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8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8/1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8/1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8/1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8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8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6/8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39552" y="4800810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S1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6" name="Picture 2" descr="C:\Users\yangyang\Desktop\图片1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67745" y="620688"/>
            <a:ext cx="4536504" cy="418012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79512" y="5589240"/>
            <a:ext cx="856895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1 Three forward primes (Fe1 N to Fe3 N), three reverse primers (Re1 N to Re3 N) and one probe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ere tried to screen the best combination yielding the highest amplification. The amplification results of nine different combinations were shown in the figure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292718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4</TotalTime>
  <Words>55</Words>
  <Application>Microsoft Office PowerPoint</Application>
  <PresentationFormat>全屏显示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ang yang</dc:creator>
  <cp:lastModifiedBy>yangyang</cp:lastModifiedBy>
  <cp:revision>8</cp:revision>
  <dcterms:created xsi:type="dcterms:W3CDTF">2016-08-01T08:35:56Z</dcterms:created>
  <dcterms:modified xsi:type="dcterms:W3CDTF">2016-08-11T07:13:23Z</dcterms:modified>
</cp:coreProperties>
</file>